
<file path=[Content_Types].xml><?xml version="1.0" encoding="utf-8"?>
<Types xmlns="http://schemas.openxmlformats.org/package/2006/content-types">
  <Default Extension="avi" ContentType="video/x-msvideo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08"/>
    <p:restoredTop sz="94580"/>
  </p:normalViewPr>
  <p:slideViewPr>
    <p:cSldViewPr snapToGrid="0" snapToObjects="1" showGuides="1">
      <p:cViewPr varScale="1">
        <p:scale>
          <a:sx n="86" d="100"/>
          <a:sy n="86" d="100"/>
        </p:scale>
        <p:origin x="1164" y="7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2239F3-67FC-F84D-A33B-EFE907F37266}" type="datetimeFigureOut">
              <a:rPr lang="en-US" smtClean="0"/>
              <a:t>12/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4F3F4C-94D5-A740-9CBA-C1F1EEB061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421366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2239F3-67FC-F84D-A33B-EFE907F37266}" type="datetimeFigureOut">
              <a:rPr lang="en-US" smtClean="0"/>
              <a:t>12/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4F3F4C-94D5-A740-9CBA-C1F1EEB061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73863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2239F3-67FC-F84D-A33B-EFE907F37266}" type="datetimeFigureOut">
              <a:rPr lang="en-US" smtClean="0"/>
              <a:t>12/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4F3F4C-94D5-A740-9CBA-C1F1EEB061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50277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2239F3-67FC-F84D-A33B-EFE907F37266}" type="datetimeFigureOut">
              <a:rPr lang="en-US" smtClean="0"/>
              <a:t>12/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4F3F4C-94D5-A740-9CBA-C1F1EEB061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51689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2239F3-67FC-F84D-A33B-EFE907F37266}" type="datetimeFigureOut">
              <a:rPr lang="en-US" smtClean="0"/>
              <a:t>12/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4F3F4C-94D5-A740-9CBA-C1F1EEB061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44111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2239F3-67FC-F84D-A33B-EFE907F37266}" type="datetimeFigureOut">
              <a:rPr lang="en-US" smtClean="0"/>
              <a:t>12/9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4F3F4C-94D5-A740-9CBA-C1F1EEB061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18547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2239F3-67FC-F84D-A33B-EFE907F37266}" type="datetimeFigureOut">
              <a:rPr lang="en-US" smtClean="0"/>
              <a:t>12/9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4F3F4C-94D5-A740-9CBA-C1F1EEB061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41322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2239F3-67FC-F84D-A33B-EFE907F37266}" type="datetimeFigureOut">
              <a:rPr lang="en-US" smtClean="0"/>
              <a:t>12/9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4F3F4C-94D5-A740-9CBA-C1F1EEB061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14691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2239F3-67FC-F84D-A33B-EFE907F37266}" type="datetimeFigureOut">
              <a:rPr lang="en-US" smtClean="0"/>
              <a:t>12/9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4F3F4C-94D5-A740-9CBA-C1F1EEB061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1523982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2239F3-67FC-F84D-A33B-EFE907F37266}" type="datetimeFigureOut">
              <a:rPr lang="en-US" smtClean="0"/>
              <a:t>12/9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4F3F4C-94D5-A740-9CBA-C1F1EEB061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7289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A2239F3-67FC-F84D-A33B-EFE907F37266}" type="datetimeFigureOut">
              <a:rPr lang="en-US" smtClean="0"/>
              <a:t>12/9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4F3F4C-94D5-A740-9CBA-C1F1EEB061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71432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A2239F3-67FC-F84D-A33B-EFE907F37266}" type="datetimeFigureOut">
              <a:rPr lang="en-US" smtClean="0"/>
              <a:t>12/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64F3F4C-94D5-A740-9CBA-C1F1EEB0619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34429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video" Target="../media/media1.avi"/><Relationship Id="rId1" Type="http://schemas.microsoft.com/office/2007/relationships/media" Target="../media/media1.avi"/><Relationship Id="rId4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Online Media 3" descr="4_C1_Crop_Filtered_Movie_3um copy_Green">
            <a:hlinkClick r:id="" action="ppaction://media"/>
            <a:extLst>
              <a:ext uri="{FF2B5EF4-FFF2-40B4-BE49-F238E27FC236}">
                <a16:creationId xmlns:a16="http://schemas.microsoft.com/office/drawing/2014/main" id="{7364AA98-F18C-9D4B-9FD1-C1A527EA40DF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2654300" y="125413"/>
            <a:ext cx="3835400" cy="383540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D7DD96F3-1298-7D44-BA07-5297BA439B1C}"/>
              </a:ext>
            </a:extLst>
          </p:cNvPr>
          <p:cNvSpPr txBox="1"/>
          <p:nvPr/>
        </p:nvSpPr>
        <p:spPr>
          <a:xfrm>
            <a:off x="0" y="4513613"/>
            <a:ext cx="914400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>
                <a:latin typeface="Palatino Linotype" panose="02040502050505030304" pitchFamily="18" charset="0"/>
              </a:rPr>
              <a:t>Video S1. </a:t>
            </a:r>
            <a:r>
              <a:rPr lang="en-US" sz="900" dirty="0">
                <a:latin typeface="Palatino Linotype" panose="02040502050505030304" pitchFamily="18" charset="0"/>
              </a:rPr>
              <a:t>360º rotation of a 3D image of a xenografted tumor. Z stacks were acquired through confocal microscopy and the 3D image was reconstructed using the Fiji software. </a:t>
            </a:r>
          </a:p>
        </p:txBody>
      </p:sp>
    </p:spTree>
    <p:extLst>
      <p:ext uri="{BB962C8B-B14F-4D97-AF65-F5344CB8AC3E}">
        <p14:creationId xmlns:p14="http://schemas.microsoft.com/office/powerpoint/2010/main" val="749003244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25714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</TotalTime>
  <Words>32</Words>
  <Application>Microsoft Office PowerPoint</Application>
  <PresentationFormat>On-screen Show (4:3)</PresentationFormat>
  <Paragraphs>1</Paragraphs>
  <Slides>1</Slides>
  <Notes>0</Notes>
  <HiddenSlides>0</HiddenSlides>
  <MMClips>1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Palatino Linotype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Valeria</cp:lastModifiedBy>
  <cp:revision>5</cp:revision>
  <dcterms:created xsi:type="dcterms:W3CDTF">2019-06-27T16:48:28Z</dcterms:created>
  <dcterms:modified xsi:type="dcterms:W3CDTF">2019-12-09T16:20:37Z</dcterms:modified>
</cp:coreProperties>
</file>